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22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annick Thonissen" initials="Y" lastIdx="1" clrIdx="0">
    <p:extLst>
      <p:ext uri="{19B8F6BF-5375-455C-9EA6-DF929625EA0E}">
        <p15:presenceInfo xmlns:p15="http://schemas.microsoft.com/office/powerpoint/2012/main" userId="Yannick Thonisse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4" d="100"/>
          <a:sy n="114" d="100"/>
        </p:scale>
        <p:origin x="28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commentAuthors" Target="commentAuthor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2" name="Google Shape;132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p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7" name="Google Shape;137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Google Shape;141;p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2" name="Google Shape;142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Google Shape;146;p1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7" name="Google Shape;147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Google Shape;151;p1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2" name="Google Shape;152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Google Shape;156;p1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7" name="Google Shape;157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Google Shape;163;p1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4" name="Google Shape;164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Google Shape;171;p1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72" name="Google Shape;172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Google Shape;178;p1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79" name="Google Shape;179;p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Google Shape;190;p1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1" name="Google Shape;191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Google Shape;196;p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7" name="Google Shape;197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7" name="Google Shape;97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2" name="Google Shape;102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7" name="Google Shape;107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p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2" name="Google Shape;112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Google Shape;116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7" name="Google Shape;117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Google Shape;121;p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2" name="Google Shape;122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p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7" name="Google Shape;127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dia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en verticale teks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e titel en teks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gelijking" type="twoTxTwoObj">
  <p:cSld name="TWO_OBJECTS_WITH_TEX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3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1" name="Google Shape;21;p3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22" name="Google Shape;22;p3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en object" type="obj">
  <p:cSld name="OBJECT">
    <p:spTree>
      <p:nvGrpSpPr>
        <p:cNvPr id="1" name="Shape 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Google Shape;27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ekop" type="secHead">
  <p:cSld name="SECTION_HEADER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houd van twee" type="twoObj">
  <p:cSld name="TWO_OBJECTS">
    <p:spTree>
      <p:nvGrpSpPr>
        <p:cNvPr id="1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lleen titel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eeg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houd met bijschrift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fbeelding met bijschrift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r.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3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3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3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3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3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3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300"/>
              <a:buFont typeface="Calibri"/>
              <a:buNone/>
            </a:pPr>
            <a:r>
              <a:rPr lang="en-US" sz="10300"/>
              <a:t>X-linked BPNH</a:t>
            </a:r>
            <a:endParaRPr/>
          </a:p>
        </p:txBody>
      </p:sp>
      <p:sp>
        <p:nvSpPr>
          <p:cNvPr id="85" name="Google Shape;85;p13"/>
          <p:cNvSpPr txBox="1">
            <a:spLocks noGrp="1"/>
          </p:cNvSpPr>
          <p:nvPr>
            <p:ph type="subTitle" idx="1"/>
          </p:nvPr>
        </p:nvSpPr>
        <p:spPr>
          <a:xfrm>
            <a:off x="4416457" y="4079875"/>
            <a:ext cx="3359085" cy="20946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7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r>
              <a:rPr lang="en-US" sz="2800"/>
              <a:t>Dr. Yannick Thonissen</a:t>
            </a:r>
            <a:endParaRPr/>
          </a:p>
          <a:p>
            <a:pPr marL="0" lvl="0" indent="0" algn="l" rtl="0">
              <a:lnSpc>
                <a:spcPct val="7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79"/>
              <a:buNone/>
            </a:pPr>
            <a:r>
              <a:rPr lang="en-US" sz="1679"/>
              <a:t>In samenwerking met: </a:t>
            </a:r>
            <a:endParaRPr/>
          </a:p>
          <a:p>
            <a:pPr marL="0" lvl="0" indent="0" algn="l" rtl="0">
              <a:lnSpc>
                <a:spcPct val="7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79"/>
              <a:buNone/>
            </a:pPr>
            <a:r>
              <a:rPr lang="en-US" sz="1679"/>
              <a:t>	Dr. M. Aertsen</a:t>
            </a:r>
            <a:endParaRPr sz="1679"/>
          </a:p>
          <a:p>
            <a:pPr marL="0" lvl="0" indent="0" algn="l" rtl="0">
              <a:lnSpc>
                <a:spcPct val="7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79"/>
              <a:buNone/>
            </a:pPr>
            <a:r>
              <a:rPr lang="en-US" sz="1679"/>
              <a:t>	Prof. Dr. L. De Catte</a:t>
            </a:r>
            <a:endParaRPr sz="1679"/>
          </a:p>
          <a:p>
            <a:pPr marL="0" lvl="0" indent="0" algn="l" rtl="0">
              <a:lnSpc>
                <a:spcPct val="7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79"/>
              <a:buNone/>
            </a:pPr>
            <a:r>
              <a:rPr lang="en-US" sz="1679"/>
              <a:t>	</a:t>
            </a:r>
            <a:endParaRPr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4" name="Google Shape;134;p22" descr="Schermopname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/>
          <a:stretch/>
        </p:blipFill>
        <p:spPr>
          <a:xfrm>
            <a:off x="-237090" y="-1663783"/>
            <a:ext cx="12666179" cy="1018556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23"/>
          <p:cNvSpPr txBox="1">
            <a:spLocks noGrp="1"/>
          </p:cNvSpPr>
          <p:nvPr>
            <p:ph type="title"/>
          </p:nvPr>
        </p:nvSpPr>
        <p:spPr>
          <a:xfrm>
            <a:off x="3984003" y="2766218"/>
            <a:ext cx="4223994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Post-Mortem MRI</a:t>
            </a:r>
            <a:endParaRPr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dk1"/>
        </a:solidFill>
        <a:effectLst/>
      </p:bgPr>
    </p:bg>
    <p:spTree>
      <p:nvGrpSpPr>
        <p:cNvPr id="1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4" name="Google Shape;144;p24" descr="Schermopname"/>
          <p:cNvPicPr preferRelativeResize="0"/>
          <p:nvPr/>
        </p:nvPicPr>
        <p:blipFill rotWithShape="1">
          <a:blip r:embed="rId3">
            <a:alphaModFix/>
          </a:blip>
          <a:srcRect l="14829" t="4053" r="33024" b="10860"/>
          <a:stretch/>
        </p:blipFill>
        <p:spPr>
          <a:xfrm>
            <a:off x="3384223" y="-852181"/>
            <a:ext cx="5571241" cy="856236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dk1"/>
        </a:solidFill>
        <a:effectLst/>
      </p:bgPr>
    </p:bg>
    <p:spTree>
      <p:nvGrpSpPr>
        <p:cNvPr id="1" name="Shape 1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9" name="Google Shape;149;p25" descr="Schermopname"/>
          <p:cNvPicPr preferRelativeResize="0"/>
          <p:nvPr/>
        </p:nvPicPr>
        <p:blipFill rotWithShape="1">
          <a:blip r:embed="rId3">
            <a:alphaModFix/>
          </a:blip>
          <a:srcRect l="16274" t="4713" r="21315"/>
          <a:stretch/>
        </p:blipFill>
        <p:spPr>
          <a:xfrm>
            <a:off x="3134360" y="536439"/>
            <a:ext cx="5923280" cy="891205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dk1"/>
        </a:solidFill>
        <a:effectLst/>
      </p:bgPr>
    </p:bg>
    <p:spTree>
      <p:nvGrpSpPr>
        <p:cNvPr id="1" name="Shape 1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4" name="Google Shape;154;p26" descr="Schermopname"/>
          <p:cNvPicPr preferRelativeResize="0"/>
          <p:nvPr/>
        </p:nvPicPr>
        <p:blipFill rotWithShape="1">
          <a:blip r:embed="rId3">
            <a:alphaModFix/>
          </a:blip>
          <a:srcRect l="18875" t="15556" r="23839" b="13185"/>
          <a:stretch/>
        </p:blipFill>
        <p:spPr>
          <a:xfrm>
            <a:off x="3403600" y="223444"/>
            <a:ext cx="5384800" cy="641111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Google Shape;159;p2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Autopsy</a:t>
            </a:r>
            <a:endParaRPr/>
          </a:p>
        </p:txBody>
      </p:sp>
      <p:sp>
        <p:nvSpPr>
          <p:cNvPr id="160" name="Google Shape;160;p27"/>
          <p:cNvSpPr txBox="1">
            <a:spLocks noGrp="1"/>
          </p:cNvSpPr>
          <p:nvPr>
            <p:ph type="body" idx="1"/>
          </p:nvPr>
        </p:nvSpPr>
        <p:spPr>
          <a:xfrm>
            <a:off x="1676400" y="1906905"/>
            <a:ext cx="10515600" cy="50323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28600" lvl="0" indent="-64135" algn="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/>
          </a:p>
          <a:p>
            <a:pPr marL="228600" lvl="0" indent="-64135" algn="r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/>
          </a:p>
          <a:p>
            <a:pPr marL="228600" lvl="0" indent="-64135" algn="r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/>
          </a:p>
          <a:p>
            <a:pPr marL="228600" lvl="0" indent="-64135" algn="r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/>
          </a:p>
          <a:p>
            <a:pPr marL="228600" lvl="0" indent="-64135" algn="r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/>
          </a:p>
          <a:p>
            <a:pPr marL="228600" lvl="0" indent="-64135" algn="r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/>
          </a:p>
          <a:p>
            <a:pPr marL="228600" lvl="0" indent="-64135" algn="r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/>
          </a:p>
          <a:p>
            <a:pPr marL="228600" lvl="0" indent="-64135" algn="r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/>
          </a:p>
          <a:p>
            <a:pPr marL="0" lvl="0" indent="0" algn="r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/>
          </a:p>
          <a:p>
            <a:pPr marL="0" lvl="0" indent="0" algn="r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/>
          </a:p>
          <a:p>
            <a:pPr marL="0" lvl="0" indent="0" algn="r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572"/>
              <a:buNone/>
            </a:pPr>
            <a:r>
              <a:rPr lang="en-US" sz="1572"/>
              <a:t>S. Stoecklein, C. Haberler, D. Prayer et al.  2017.</a:t>
            </a:r>
            <a:br>
              <a:rPr lang="en-US" sz="1572"/>
            </a:br>
            <a:r>
              <a:rPr lang="en-US" sz="1572"/>
              <a:t>doi: 10.1002/uog.18991</a:t>
            </a:r>
            <a:endParaRPr/>
          </a:p>
        </p:txBody>
      </p:sp>
      <p:pic>
        <p:nvPicPr>
          <p:cNvPr id="161" name="Google Shape;161;p2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343853" y="1119346"/>
            <a:ext cx="5504294" cy="495386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Google Shape;166;p2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Diagnosis?</a:t>
            </a:r>
            <a:endParaRPr/>
          </a:p>
        </p:txBody>
      </p:sp>
      <p:sp>
        <p:nvSpPr>
          <p:cNvPr id="167" name="Google Shape;167;p28"/>
          <p:cNvSpPr txBox="1">
            <a:spLocks noGrp="1"/>
          </p:cNvSpPr>
          <p:nvPr>
            <p:ph type="body" idx="1"/>
          </p:nvPr>
        </p:nvSpPr>
        <p:spPr>
          <a:xfrm>
            <a:off x="838200" y="1690688"/>
            <a:ext cx="10515600" cy="50323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sz="3200"/>
              <a:t>Bilateral periventricular nodular heterotopy </a:t>
            </a:r>
            <a:endParaRPr/>
          </a:p>
          <a:p>
            <a:pPr marL="22860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4000"/>
              <a:buNone/>
            </a:pPr>
            <a:endParaRPr sz="4000"/>
          </a:p>
          <a:p>
            <a:pPr marL="22860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</a:pPr>
            <a:endParaRPr sz="3600"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</a:pPr>
            <a:endParaRPr sz="3600"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600"/>
              <a:buNone/>
            </a:pPr>
            <a:endParaRPr sz="360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sz="3200"/>
              <a:t>Megacisterna magna</a:t>
            </a:r>
            <a:endParaRPr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endParaRPr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Underlying cause?</a:t>
            </a:r>
            <a:endParaRPr/>
          </a:p>
          <a:p>
            <a:pPr marL="1143000" lvl="2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</a:pPr>
            <a:r>
              <a:rPr lang="en-US"/>
              <a:t>PFNA?  -&gt; Genetic screening confirms!</a:t>
            </a:r>
            <a:endParaRPr/>
          </a:p>
          <a:p>
            <a:pPr marL="228600" lvl="0" indent="-508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endParaRPr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endParaRPr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endParaRPr/>
          </a:p>
        </p:txBody>
      </p:sp>
      <p:pic>
        <p:nvPicPr>
          <p:cNvPr id="168" name="Google Shape;168;p28" descr="Schermopname"/>
          <p:cNvPicPr preferRelativeResize="0"/>
          <p:nvPr/>
        </p:nvPicPr>
        <p:blipFill rotWithShape="1">
          <a:blip r:embed="rId3">
            <a:alphaModFix/>
          </a:blip>
          <a:srcRect l="15649" t="18466" r="33759" b="21676"/>
          <a:stretch/>
        </p:blipFill>
        <p:spPr>
          <a:xfrm>
            <a:off x="1154314" y="2355602"/>
            <a:ext cx="1926365" cy="2146796"/>
          </a:xfrm>
          <a:prstGeom prst="rect">
            <a:avLst/>
          </a:prstGeom>
          <a:noFill/>
          <a:ln>
            <a:noFill/>
          </a:ln>
        </p:spPr>
      </p:pic>
      <p:pic>
        <p:nvPicPr>
          <p:cNvPr id="169" name="Google Shape;169;p28" descr="Schermopname"/>
          <p:cNvPicPr preferRelativeResize="0"/>
          <p:nvPr/>
        </p:nvPicPr>
        <p:blipFill rotWithShape="1">
          <a:blip r:embed="rId4">
            <a:alphaModFix/>
          </a:blip>
          <a:srcRect l="4047" t="10915" r="27396" b="9103"/>
          <a:stretch/>
        </p:blipFill>
        <p:spPr>
          <a:xfrm rot="10800000" flipH="1">
            <a:off x="3491899" y="2355602"/>
            <a:ext cx="2604101" cy="214679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7" fill="hold">
                      <p:stCondLst>
                        <p:cond delay="indefinite"/>
                      </p:stCondLst>
                      <p:childTnLst>
                        <p:par>
                          <p:cTn id="48" fill="hold">
                            <p:stCondLst>
                              <p:cond delay="0"/>
                            </p:stCondLst>
                            <p:childTnLst>
                              <p:par>
                                <p:cTn id="4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5" fill="hold">
                      <p:stCondLst>
                        <p:cond delay="indefinite"/>
                      </p:stCondLst>
                      <p:childTnLst>
                        <p:par>
                          <p:cTn id="56" fill="hold">
                            <p:stCondLst>
                              <p:cond delay="0"/>
                            </p:stCondLst>
                            <p:childTnLst>
                              <p:par>
                                <p:cTn id="5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Google Shape;174;p2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FLNA</a:t>
            </a:r>
            <a:endParaRPr/>
          </a:p>
        </p:txBody>
      </p:sp>
      <p:sp>
        <p:nvSpPr>
          <p:cNvPr id="175" name="Google Shape;175;p2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Xq28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F-actin binding </a:t>
            </a:r>
            <a:r>
              <a:rPr lang="en-US" dirty="0" err="1"/>
              <a:t>cystoplasmatic</a:t>
            </a:r>
            <a:r>
              <a:rPr lang="en-US" dirty="0"/>
              <a:t> phosphoprotein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 dirty="0"/>
              <a:t>Neural migration</a:t>
            </a:r>
            <a:endParaRPr dirty="0"/>
          </a:p>
        </p:txBody>
      </p:sp>
      <p:pic>
        <p:nvPicPr>
          <p:cNvPr id="176" name="Google Shape;176;p29" descr="Image result for filamin a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011498" y="2957513"/>
            <a:ext cx="5715000" cy="321945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kstvak 3"/>
          <p:cNvSpPr txBox="1"/>
          <p:nvPr/>
        </p:nvSpPr>
        <p:spPr>
          <a:xfrm>
            <a:off x="0" y="6318250"/>
            <a:ext cx="10743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Yue, J., </a:t>
            </a:r>
            <a:r>
              <a:rPr lang="en-US" dirty="0" err="1"/>
              <a:t>Huhn</a:t>
            </a:r>
            <a:r>
              <a:rPr lang="en-US" dirty="0"/>
              <a:t>, S. &amp; Shen, Z. Complex roles of </a:t>
            </a:r>
            <a:r>
              <a:rPr lang="en-US" dirty="0" err="1"/>
              <a:t>filamin</a:t>
            </a:r>
            <a:r>
              <a:rPr lang="en-US" dirty="0"/>
              <a:t>-A mediated cytoskeleton network in cancer progression. </a:t>
            </a:r>
            <a:r>
              <a:rPr lang="en-US" i="1" dirty="0"/>
              <a:t>Cell </a:t>
            </a:r>
            <a:r>
              <a:rPr lang="en-US" i="1" dirty="0" err="1"/>
              <a:t>Biosci</a:t>
            </a:r>
            <a:r>
              <a:rPr lang="en-US" dirty="0"/>
              <a:t> </a:t>
            </a:r>
            <a:r>
              <a:rPr lang="en-US" b="1" dirty="0"/>
              <a:t>3, </a:t>
            </a:r>
            <a:r>
              <a:rPr lang="en-US" dirty="0"/>
              <a:t>7 (2013).</a:t>
            </a:r>
            <a:endParaRPr lang="nl-BE" dirty="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1" name="Google Shape;181;p3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164696" y="183823"/>
            <a:ext cx="3455268" cy="2243594"/>
          </a:xfrm>
          <a:prstGeom prst="rect">
            <a:avLst/>
          </a:prstGeom>
          <a:noFill/>
          <a:ln>
            <a:noFill/>
          </a:ln>
        </p:spPr>
      </p:pic>
      <p:sp>
        <p:nvSpPr>
          <p:cNvPr id="182" name="Google Shape;182;p3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FLNA</a:t>
            </a:r>
            <a:endParaRPr/>
          </a:p>
        </p:txBody>
      </p:sp>
      <p:sp>
        <p:nvSpPr>
          <p:cNvPr id="183" name="Google Shape;183;p30"/>
          <p:cNvSpPr txBox="1">
            <a:spLocks noGrp="1"/>
          </p:cNvSpPr>
          <p:nvPr>
            <p:ph type="body" idx="1"/>
          </p:nvPr>
        </p:nvSpPr>
        <p:spPr>
          <a:xfrm>
            <a:off x="836612" y="1435100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/>
              <a:t>Female phenotypes</a:t>
            </a:r>
            <a:endParaRPr/>
          </a:p>
        </p:txBody>
      </p:sp>
      <p:sp>
        <p:nvSpPr>
          <p:cNvPr id="184" name="Google Shape;184;p3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41691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Clinical phenotypes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Epilepsy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Mental retardation (mild)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Cardiovascular problems</a:t>
            </a:r>
            <a:endParaRPr/>
          </a:p>
          <a:p>
            <a:pPr marL="1143000" lvl="2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</a:pPr>
            <a:r>
              <a:rPr lang="en-US"/>
              <a:t>Aortic valve insufficiency </a:t>
            </a:r>
            <a:endParaRPr/>
          </a:p>
          <a:p>
            <a:pPr marL="1143000" lvl="2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</a:pPr>
            <a:r>
              <a:rPr lang="en-US"/>
              <a:t>Patent ductus arteriosus</a:t>
            </a:r>
            <a:endParaRPr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Imaging phenotypes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BNPH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Megacisterna magna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Thinning of the corpus callosum</a:t>
            </a:r>
            <a:endParaRPr/>
          </a:p>
          <a:p>
            <a:pPr marL="0" lvl="0" indent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endParaRPr/>
          </a:p>
        </p:txBody>
      </p:sp>
      <p:sp>
        <p:nvSpPr>
          <p:cNvPr id="185" name="Google Shape;185;p30"/>
          <p:cNvSpPr txBox="1">
            <a:spLocks noGrp="1"/>
          </p:cNvSpPr>
          <p:nvPr>
            <p:ph type="body" idx="3"/>
          </p:nvPr>
        </p:nvSpPr>
        <p:spPr>
          <a:xfrm>
            <a:off x="6175376" y="1435100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/>
              <a:t>Male phenotypes</a:t>
            </a:r>
            <a:endParaRPr/>
          </a:p>
        </p:txBody>
      </p:sp>
      <p:sp>
        <p:nvSpPr>
          <p:cNvPr id="186" name="Google Shape;186;p3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Clinical phenotypes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Intra-uterine death</a:t>
            </a:r>
            <a:endParaRPr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Google Shape;193;p3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Genetic counseling</a:t>
            </a:r>
            <a:endParaRPr/>
          </a:p>
        </p:txBody>
      </p:sp>
      <p:sp>
        <p:nvSpPr>
          <p:cNvPr id="194" name="Google Shape;194;p3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Should the other daughter be screened?</a:t>
            </a:r>
            <a:endParaRPr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What is the repetition chance in a next pregnancy? 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Male? 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Female?</a:t>
            </a:r>
            <a:endParaRPr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Pre-implantation genetic diagnosis?</a:t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p14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Meeting the patients</a:t>
            </a:r>
            <a:endParaRPr/>
          </a:p>
        </p:txBody>
      </p:sp>
      <p:sp>
        <p:nvSpPr>
          <p:cNvPr id="91" name="Google Shape;91;p14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/>
              <a:t>Mother</a:t>
            </a:r>
            <a:endParaRPr/>
          </a:p>
        </p:txBody>
      </p:sp>
      <p:sp>
        <p:nvSpPr>
          <p:cNvPr id="92" name="Google Shape;92;p14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28600" lvl="0" indent="-22860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‘Normal’ age</a:t>
            </a:r>
            <a:endParaRPr/>
          </a:p>
          <a:p>
            <a:pPr marL="228600" lvl="0" indent="-228600" algn="l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Gravida: 	2</a:t>
            </a:r>
            <a:br>
              <a:rPr lang="en-US"/>
            </a:br>
            <a:r>
              <a:rPr lang="en-US"/>
              <a:t>Para: 	1</a:t>
            </a:r>
            <a:endParaRPr/>
          </a:p>
          <a:p>
            <a:pPr marL="685800" lvl="1" indent="-228600" algn="l" rtl="0">
              <a:lnSpc>
                <a:spcPct val="8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2016;  healthy girl</a:t>
            </a:r>
            <a:endParaRPr/>
          </a:p>
          <a:p>
            <a:pPr marL="228600" lvl="0" indent="-228600" algn="l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Spontaneous pregnancies</a:t>
            </a:r>
            <a:endParaRPr/>
          </a:p>
          <a:p>
            <a:pPr marL="685800" lvl="1" indent="-76200" algn="l" rtl="0">
              <a:lnSpc>
                <a:spcPct val="8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endParaRPr/>
          </a:p>
          <a:p>
            <a:pPr marL="228600" lvl="0" indent="-228600" algn="l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Medical history: /</a:t>
            </a:r>
            <a:endParaRPr/>
          </a:p>
          <a:p>
            <a:pPr marL="228600" lvl="0" indent="-228600" algn="l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Familial history: /</a:t>
            </a:r>
            <a:endParaRPr/>
          </a:p>
        </p:txBody>
      </p:sp>
      <p:sp>
        <p:nvSpPr>
          <p:cNvPr id="93" name="Google Shape;93;p14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/>
              <a:t>Fetus (Daughter)</a:t>
            </a:r>
            <a:endParaRPr/>
          </a:p>
        </p:txBody>
      </p:sp>
      <p:sp>
        <p:nvSpPr>
          <p:cNvPr id="94" name="Google Shape;94;p14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28600" lvl="0" indent="-22860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25 weeks</a:t>
            </a:r>
            <a:endParaRPr/>
          </a:p>
          <a:p>
            <a:pPr marL="228600" lvl="0" indent="-228600" algn="l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/>
              <a:t>Referral: </a:t>
            </a:r>
            <a:endParaRPr/>
          </a:p>
          <a:p>
            <a:pPr marL="685800" lvl="1" indent="-228600" algn="l" rtl="0">
              <a:lnSpc>
                <a:spcPct val="8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Mega cisterna magna. </a:t>
            </a:r>
            <a:endParaRPr/>
          </a:p>
          <a:p>
            <a:pPr marL="685800" lvl="1" indent="-228600" algn="l" rtl="0">
              <a:lnSpc>
                <a:spcPct val="8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/>
              <a:t>Structural anomaly?</a:t>
            </a:r>
            <a:endParaRPr/>
          </a:p>
          <a:p>
            <a:pPr marL="457200" lvl="1" indent="0" algn="l" rtl="0">
              <a:lnSpc>
                <a:spcPct val="8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/>
              <a:t>    </a:t>
            </a:r>
            <a:endParaRPr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Google Shape;199;p3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References</a:t>
            </a:r>
            <a:endParaRPr/>
          </a:p>
        </p:txBody>
      </p:sp>
      <p:sp>
        <p:nvSpPr>
          <p:cNvPr id="200" name="Google Shape;200;p32"/>
          <p:cNvSpPr txBox="1">
            <a:spLocks noGrp="1"/>
          </p:cNvSpPr>
          <p:nvPr>
            <p:ph type="body" idx="1"/>
          </p:nvPr>
        </p:nvSpPr>
        <p:spPr>
          <a:xfrm>
            <a:off x="838200" y="1423447"/>
            <a:ext cx="10515600" cy="4753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90"/>
              <a:buChar char="•"/>
            </a:pPr>
            <a:r>
              <a:rPr lang="en-US" sz="2590" dirty="0" smtClean="0"/>
              <a:t>Chen MH, Walsh CA. </a:t>
            </a:r>
            <a:r>
              <a:rPr lang="en-US" sz="2590" dirty="0"/>
              <a:t>FLNA-Related Periventricular Nodular Heterotopia.  </a:t>
            </a:r>
            <a:r>
              <a:rPr lang="en-US" sz="2590" i="1" dirty="0" err="1"/>
              <a:t>GeneReviews</a:t>
            </a:r>
            <a:r>
              <a:rPr lang="en-US" sz="2590" i="1" dirty="0"/>
              <a:t>®</a:t>
            </a:r>
            <a:r>
              <a:rPr lang="en-US" sz="2590" b="1" baseline="30000" dirty="0"/>
              <a:t> </a:t>
            </a:r>
            <a:r>
              <a:rPr lang="en-US" sz="2590" dirty="0"/>
              <a:t>September 17, 2015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Char char="•"/>
            </a:pPr>
            <a:r>
              <a:rPr lang="en-US" sz="2590" dirty="0" smtClean="0"/>
              <a:t>Stoecklein S, </a:t>
            </a:r>
            <a:r>
              <a:rPr lang="en-US" sz="2590" dirty="0" err="1" smtClean="0"/>
              <a:t>Haberler</a:t>
            </a:r>
            <a:r>
              <a:rPr lang="en-US" sz="2590" dirty="0" smtClean="0"/>
              <a:t> C, Gruber G, </a:t>
            </a:r>
            <a:r>
              <a:rPr lang="en-US" sz="2590" dirty="0" err="1" smtClean="0"/>
              <a:t>Diogo</a:t>
            </a:r>
            <a:r>
              <a:rPr lang="en-US" sz="2590" dirty="0" smtClean="0"/>
              <a:t> M, Ulm B,  </a:t>
            </a:r>
            <a:r>
              <a:rPr lang="en-US" sz="2590" dirty="0"/>
              <a:t> </a:t>
            </a:r>
            <a:r>
              <a:rPr lang="en-US" sz="2590" dirty="0" err="1" smtClean="0"/>
              <a:t>Laccone</a:t>
            </a:r>
            <a:r>
              <a:rPr lang="en-US" sz="2590" dirty="0" smtClean="0"/>
              <a:t> FA, Prayer D. </a:t>
            </a:r>
            <a:r>
              <a:rPr lang="en-US" sz="2590" dirty="0"/>
              <a:t>Bilateral periventricular nodular heterotopia (BPNH) detected on fetal and maternal MRI, caused by a novel </a:t>
            </a:r>
            <a:r>
              <a:rPr lang="en-US" sz="2590" dirty="0" err="1"/>
              <a:t>Filamin</a:t>
            </a:r>
            <a:r>
              <a:rPr lang="en-US" sz="2590" dirty="0"/>
              <a:t> A mutation. </a:t>
            </a:r>
            <a:r>
              <a:rPr lang="en-US" sz="2590" i="1" dirty="0"/>
              <a:t>Ultrasound </a:t>
            </a:r>
            <a:r>
              <a:rPr lang="en-US" sz="2590" i="1" dirty="0" err="1"/>
              <a:t>Obstet</a:t>
            </a:r>
            <a:r>
              <a:rPr lang="en-US" sz="2590" i="1" dirty="0"/>
              <a:t> Gynecol.</a:t>
            </a:r>
            <a:r>
              <a:rPr lang="en-US" sz="2590" dirty="0"/>
              <a:t> 2017 Dec 20 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Char char="•"/>
            </a:pPr>
            <a:r>
              <a:rPr lang="en-US" sz="2590" dirty="0" err="1"/>
              <a:t>Parrini</a:t>
            </a:r>
            <a:r>
              <a:rPr lang="en-US" sz="2590" dirty="0"/>
              <a:t> E, </a:t>
            </a:r>
            <a:r>
              <a:rPr lang="en-US" sz="2590" dirty="0" err="1"/>
              <a:t>Ramazzotti</a:t>
            </a:r>
            <a:r>
              <a:rPr lang="en-US" sz="2590" dirty="0"/>
              <a:t> A, </a:t>
            </a:r>
            <a:r>
              <a:rPr lang="en-US" sz="2590" dirty="0" err="1"/>
              <a:t>Dobyns</a:t>
            </a:r>
            <a:r>
              <a:rPr lang="en-US" sz="2590" dirty="0"/>
              <a:t> WB, et al. Periventricular </a:t>
            </a:r>
            <a:r>
              <a:rPr lang="en-US" sz="2590" dirty="0" smtClean="0"/>
              <a:t>heterotopy: </a:t>
            </a:r>
            <a:r>
              <a:rPr lang="en-US" sz="2590" dirty="0" err="1"/>
              <a:t>photypic</a:t>
            </a:r>
            <a:r>
              <a:rPr lang="en-US" sz="2590" dirty="0"/>
              <a:t> </a:t>
            </a:r>
            <a:r>
              <a:rPr lang="en-US" sz="2590" dirty="0" smtClean="0"/>
              <a:t>heterogeneity </a:t>
            </a:r>
            <a:r>
              <a:rPr lang="en-US" sz="2590" dirty="0"/>
              <a:t>and correlation with </a:t>
            </a:r>
            <a:r>
              <a:rPr lang="en-US" sz="2590" dirty="0" err="1"/>
              <a:t>filamin</a:t>
            </a:r>
            <a:r>
              <a:rPr lang="en-US" sz="2590" dirty="0"/>
              <a:t> A mutations. </a:t>
            </a:r>
            <a:r>
              <a:rPr lang="en-US" sz="2590" i="1" dirty="0"/>
              <a:t>Brain; a journal of neurology</a:t>
            </a:r>
            <a:r>
              <a:rPr lang="en-US" sz="2590" dirty="0"/>
              <a:t>. 2006; 129:1892-906</a:t>
            </a:r>
            <a:endParaRPr dirty="0"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Char char="•"/>
            </a:pPr>
            <a:r>
              <a:rPr lang="en-US" sz="2590" dirty="0" err="1"/>
              <a:t>Dhouib</a:t>
            </a:r>
            <a:r>
              <a:rPr lang="en-US" sz="2590" dirty="0"/>
              <a:t> A, </a:t>
            </a:r>
            <a:r>
              <a:rPr lang="en-US" sz="2590" dirty="0" err="1"/>
              <a:t>Blondiaux</a:t>
            </a:r>
            <a:r>
              <a:rPr lang="en-US" sz="2590" dirty="0"/>
              <a:t> E, </a:t>
            </a:r>
            <a:r>
              <a:rPr lang="en-US" sz="2590" dirty="0" err="1"/>
              <a:t>Moutard</a:t>
            </a:r>
            <a:r>
              <a:rPr lang="en-US" sz="2590" dirty="0"/>
              <a:t> ML, de </a:t>
            </a:r>
            <a:r>
              <a:rPr lang="en-US" sz="2590" dirty="0" err="1"/>
              <a:t>Villemaur</a:t>
            </a:r>
            <a:r>
              <a:rPr lang="en-US" sz="2590" dirty="0"/>
              <a:t> TB, </a:t>
            </a:r>
            <a:r>
              <a:rPr lang="en-US" sz="2590" dirty="0" err="1"/>
              <a:t>Chalard</a:t>
            </a:r>
            <a:r>
              <a:rPr lang="en-US" sz="2590" dirty="0"/>
              <a:t> F, </a:t>
            </a:r>
            <a:r>
              <a:rPr lang="en-US" sz="2590" dirty="0" err="1"/>
              <a:t>Jouannic</a:t>
            </a:r>
            <a:r>
              <a:rPr lang="en-US" sz="2590" dirty="0"/>
              <a:t> JM, le Pointe HD, </a:t>
            </a:r>
            <a:r>
              <a:rPr lang="en-US" sz="2590" dirty="0" err="1"/>
              <a:t>Garal</a:t>
            </a:r>
            <a:r>
              <a:rPr lang="en-US" sz="2590" dirty="0"/>
              <a:t> C. Correlation between pre- and postnatal cerebral magnetic resonance imaging. </a:t>
            </a:r>
            <a:r>
              <a:rPr lang="en-US" sz="2590" i="1" smtClean="0"/>
              <a:t>Ultrasound </a:t>
            </a:r>
            <a:r>
              <a:rPr lang="en-US" sz="2590" i="1" dirty="0" err="1"/>
              <a:t>obst</a:t>
            </a:r>
            <a:r>
              <a:rPr lang="en-US" sz="2590" i="1" dirty="0"/>
              <a:t> Gyn. </a:t>
            </a:r>
            <a:r>
              <a:rPr lang="en-US" sz="2590" dirty="0"/>
              <a:t>2011; 38:170-80.</a:t>
            </a:r>
            <a:endParaRPr dirty="0"/>
          </a:p>
          <a:p>
            <a:pPr marL="228600" lvl="0" indent="-64135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 dirty="0"/>
          </a:p>
          <a:p>
            <a:pPr marL="228600" lvl="0" indent="-64135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p15"/>
          <p:cNvSpPr txBox="1">
            <a:spLocks noGrp="1"/>
          </p:cNvSpPr>
          <p:nvPr>
            <p:ph type="title"/>
          </p:nvPr>
        </p:nvSpPr>
        <p:spPr>
          <a:xfrm>
            <a:off x="3715339" y="2766218"/>
            <a:ext cx="4761322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Prenatal Ultrasound</a:t>
            </a:r>
            <a:endParaRPr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dk1"/>
        </a:solidFill>
        <a:effectLst/>
      </p:bgPr>
    </p:bg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Google Shape;104;p16" descr="Schermopnam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243383" y="0"/>
            <a:ext cx="9705234" cy="6858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dk1"/>
        </a:solidFill>
        <a:effectLst/>
      </p:bgPr>
    </p:bg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Google Shape;109;p17" descr="Schermopnam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79251" y="-52252"/>
            <a:ext cx="9833497" cy="69625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dk1"/>
        </a:solidFill>
        <a:effectLst/>
      </p:bgPr>
    </p:bg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Google Shape;114;p18" descr="Schermopname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/>
          <a:stretch/>
        </p:blipFill>
        <p:spPr>
          <a:xfrm>
            <a:off x="1156804" y="0"/>
            <a:ext cx="9878400" cy="6858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p19"/>
          <p:cNvSpPr txBox="1">
            <a:spLocks noGrp="1"/>
          </p:cNvSpPr>
          <p:nvPr>
            <p:ph type="title"/>
          </p:nvPr>
        </p:nvSpPr>
        <p:spPr>
          <a:xfrm>
            <a:off x="4507190" y="2766218"/>
            <a:ext cx="3177619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Prenatal MRI</a:t>
            </a:r>
            <a:endParaRPr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dk1"/>
        </a:solidFill>
        <a:effectLst/>
      </p:bgPr>
    </p:bg>
    <p:spTree>
      <p:nvGrpSpPr>
        <p:cNvPr id="1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Google Shape;124;p20" descr="Schermopnam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414365" y="-1548270"/>
            <a:ext cx="7363270" cy="840627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" name="Google Shape;129;p21" descr="Schermopnam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003" y="-1114181"/>
            <a:ext cx="12474006" cy="1004593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373</Words>
  <Application>Microsoft Office PowerPoint</Application>
  <PresentationFormat>Breedbeeld</PresentationFormat>
  <Paragraphs>78</Paragraphs>
  <Slides>20</Slides>
  <Notes>2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2</vt:i4>
      </vt:variant>
      <vt:variant>
        <vt:lpstr>Thema</vt:lpstr>
      </vt:variant>
      <vt:variant>
        <vt:i4>1</vt:i4>
      </vt:variant>
      <vt:variant>
        <vt:lpstr>Diatitels</vt:lpstr>
      </vt:variant>
      <vt:variant>
        <vt:i4>20</vt:i4>
      </vt:variant>
    </vt:vector>
  </HeadingPairs>
  <TitlesOfParts>
    <vt:vector size="23" baseType="lpstr">
      <vt:lpstr>Arial</vt:lpstr>
      <vt:lpstr>Calibri</vt:lpstr>
      <vt:lpstr>Kantoorthema</vt:lpstr>
      <vt:lpstr>X-linked BPNH</vt:lpstr>
      <vt:lpstr>Meeting the patients</vt:lpstr>
      <vt:lpstr>Prenatal Ultrasound</vt:lpstr>
      <vt:lpstr>PowerPoint-presentatie</vt:lpstr>
      <vt:lpstr>PowerPoint-presentatie</vt:lpstr>
      <vt:lpstr>PowerPoint-presentatie</vt:lpstr>
      <vt:lpstr>Prenatal MRI</vt:lpstr>
      <vt:lpstr>PowerPoint-presentatie</vt:lpstr>
      <vt:lpstr>PowerPoint-presentatie</vt:lpstr>
      <vt:lpstr>PowerPoint-presentatie</vt:lpstr>
      <vt:lpstr>Post-Mortem MRI</vt:lpstr>
      <vt:lpstr>PowerPoint-presentatie</vt:lpstr>
      <vt:lpstr>PowerPoint-presentatie</vt:lpstr>
      <vt:lpstr>PowerPoint-presentatie</vt:lpstr>
      <vt:lpstr>Autopsy</vt:lpstr>
      <vt:lpstr>Diagnosis?</vt:lpstr>
      <vt:lpstr>FLNA</vt:lpstr>
      <vt:lpstr>FLNA</vt:lpstr>
      <vt:lpstr>Genetic counseling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X-linked BPNH</dc:title>
  <dc:creator>Yannick Thonissen</dc:creator>
  <cp:lastModifiedBy>Yannick Thonissen</cp:lastModifiedBy>
  <cp:revision>4</cp:revision>
  <dcterms:modified xsi:type="dcterms:W3CDTF">2020-04-29T15:27:17Z</dcterms:modified>
</cp:coreProperties>
</file>